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altLang="nl-NL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5" name="Picture 1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21" t="12138" r="4936" b="17776"/>
          <a:stretch>
            <a:fillRect/>
          </a:stretch>
        </p:blipFill>
        <p:spPr bwMode="auto">
          <a:xfrm>
            <a:off x="609600" y="173764"/>
            <a:ext cx="7524750" cy="40290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52400" y="4249841"/>
            <a:ext cx="8686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djuvanted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V induces cross-reactive but non-neutralizing antibodies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(n=6/group) were immunized as described in the legend for Fig. 1. After 3 vaccinations, systemic immune responses were determined in serum. The functional potential of serum antibodies was determined by MN assay against PR8 (A), A(H1N1)pdm09 (B) and  X-31 (C) viruses. IgG titers were determined by ELISA using as coating antigens PR8 WIV (D), A/California/7/2009 (H1N1)pdm09 WIV (E) or  X-31 WIV (F). Groups are represented as in Table 1:  1: PBS, 2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3: WIV+CAF01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4: WIV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5: WIV+ CAF09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6: WIV+ CTA1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 7: WIV+ CTA1-3Me-D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.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shed lines indicat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N titers are represented as 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ters while IgG titers are represented as log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iters, with level of significance as *p&lt;.05,  **p&lt;.01 and ***p&lt;0.001, calculated using Mann-Whitney U-test.</a:t>
            </a:r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nl-N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35886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>Y.C. Bhide</cp:lastModifiedBy>
  <cp:revision>1</cp:revision>
  <dcterms:created xsi:type="dcterms:W3CDTF">2006-08-16T00:00:00Z</dcterms:created>
  <dcterms:modified xsi:type="dcterms:W3CDTF">2018-09-27T11:54:58Z</dcterms:modified>
</cp:coreProperties>
</file>